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082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550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8076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5047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248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570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345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95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358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5081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9907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325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D3AE71DE-19C2-218F-3832-3478A5D1B56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274" t="13600" r="6037" b="11073"/>
          <a:stretch/>
        </p:blipFill>
        <p:spPr>
          <a:xfrm>
            <a:off x="433310" y="500370"/>
            <a:ext cx="1534395" cy="136090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516D4FD5-9298-FA5D-C3FF-CBFC94631F1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662" t="11479" r="5230" b="14395"/>
          <a:stretch/>
        </p:blipFill>
        <p:spPr>
          <a:xfrm>
            <a:off x="3292174" y="460325"/>
            <a:ext cx="1541830" cy="1339216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4B74A9C7-CC13-7C15-C26F-EB25E054E5B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926" t="11512" r="4759" b="15352"/>
          <a:stretch/>
        </p:blipFill>
        <p:spPr>
          <a:xfrm>
            <a:off x="5117535" y="478232"/>
            <a:ext cx="1563159" cy="1321309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BF7C0F62-9726-4857-1D51-99BD446A4B1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905" t="9914" r="5226" b="8854"/>
          <a:stretch/>
        </p:blipFill>
        <p:spPr>
          <a:xfrm>
            <a:off x="413389" y="2149807"/>
            <a:ext cx="1572971" cy="1467592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0DFB4490-8C25-BAF2-AB08-7D909B683B3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484" t="10253" r="5084" b="15621"/>
          <a:stretch/>
        </p:blipFill>
        <p:spPr>
          <a:xfrm>
            <a:off x="3269166" y="2152969"/>
            <a:ext cx="1600642" cy="1339216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4B8E6743-8AAE-7113-DEDB-51D05F25873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070" t="11479" r="5616" b="15386"/>
          <a:stretch/>
        </p:blipFill>
        <p:spPr>
          <a:xfrm>
            <a:off x="5117535" y="2151236"/>
            <a:ext cx="1563159" cy="1321309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BB62A8D6-8F9C-ECB6-A863-BD83D17ED10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121" t="9915" r="5010" b="9609"/>
          <a:stretch/>
        </p:blipFill>
        <p:spPr>
          <a:xfrm>
            <a:off x="391952" y="3815446"/>
            <a:ext cx="1572972" cy="145394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1614B2A7-656D-8D40-23B5-E83513D86F74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678" t="10253" r="5740" b="15621"/>
          <a:stretch/>
        </p:blipFill>
        <p:spPr>
          <a:xfrm>
            <a:off x="3269166" y="3833457"/>
            <a:ext cx="1567922" cy="1339216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08D4BD4E-E363-5523-81CF-B1BE2F031D1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4784" t="11479" r="5375" b="15019"/>
          <a:stretch/>
        </p:blipFill>
        <p:spPr>
          <a:xfrm>
            <a:off x="5103771" y="3844726"/>
            <a:ext cx="1590187" cy="1327947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523935AE-6FD4-7B87-87FE-14EE88431B2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5383" t="10528" r="5043" b="8240"/>
          <a:stretch/>
        </p:blipFill>
        <p:spPr>
          <a:xfrm>
            <a:off x="363477" y="5479212"/>
            <a:ext cx="1585457" cy="1467592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B183E2F8-252A-8DFF-52C3-436D7D4A62C6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716" t="12941" r="5478" b="13907"/>
          <a:stretch/>
        </p:blipFill>
        <p:spPr>
          <a:xfrm>
            <a:off x="3276277" y="5532522"/>
            <a:ext cx="1554166" cy="1321636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3210ED70-F594-BF19-3C3D-89194F0B95CD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6096" t="11480" r="4330" b="14284"/>
          <a:stretch/>
        </p:blipFill>
        <p:spPr>
          <a:xfrm>
            <a:off x="5117535" y="5499096"/>
            <a:ext cx="1585457" cy="1341189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B7E3B5FA-2769-DB6C-DE21-C25D515BB363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3842" t="9914" r="2211" b="8854"/>
          <a:stretch/>
        </p:blipFill>
        <p:spPr>
          <a:xfrm>
            <a:off x="363477" y="7116870"/>
            <a:ext cx="1662882" cy="1467592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5BE263D1-6AA4-D12C-7FAC-5A41D240283C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6052" t="10253" r="4675" b="15512"/>
          <a:stretch/>
        </p:blipFill>
        <p:spPr>
          <a:xfrm>
            <a:off x="3289672" y="7137605"/>
            <a:ext cx="1580136" cy="1341189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B91C5863-4289-B7FA-C70E-60EA05A0E4D8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4107" t="11479" r="6053" b="14285"/>
          <a:stretch/>
        </p:blipFill>
        <p:spPr>
          <a:xfrm>
            <a:off x="5105208" y="7160430"/>
            <a:ext cx="1590188" cy="1341189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18E8468-550F-54A4-EF31-F55E97BB5694}"/>
              </a:ext>
            </a:extLst>
          </p:cNvPr>
          <p:cNvSpPr txBox="1"/>
          <p:nvPr/>
        </p:nvSpPr>
        <p:spPr>
          <a:xfrm>
            <a:off x="549000" y="1450085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923AF60-CAF8-C4B3-965E-7E2BE9005EE0}"/>
              </a:ext>
            </a:extLst>
          </p:cNvPr>
          <p:cNvSpPr txBox="1"/>
          <p:nvPr/>
        </p:nvSpPr>
        <p:spPr>
          <a:xfrm>
            <a:off x="865518" y="1861278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68C8951-11F4-6160-C622-5F2D3D85D440}"/>
              </a:ext>
            </a:extLst>
          </p:cNvPr>
          <p:cNvSpPr txBox="1"/>
          <p:nvPr/>
        </p:nvSpPr>
        <p:spPr>
          <a:xfrm>
            <a:off x="3508362" y="178144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CA803D9-1AE3-8795-77BF-A102F2041B94}"/>
              </a:ext>
            </a:extLst>
          </p:cNvPr>
          <p:cNvSpPr txBox="1"/>
          <p:nvPr/>
        </p:nvSpPr>
        <p:spPr>
          <a:xfrm>
            <a:off x="3791109" y="1781447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EEB9218-44A7-B8E2-BC24-5E1A63350F8A}"/>
              </a:ext>
            </a:extLst>
          </p:cNvPr>
          <p:cNvSpPr txBox="1"/>
          <p:nvPr/>
        </p:nvSpPr>
        <p:spPr>
          <a:xfrm>
            <a:off x="4386571" y="1788811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A1A52B2-CF1B-9F02-2422-38ED46241C6F}"/>
              </a:ext>
            </a:extLst>
          </p:cNvPr>
          <p:cNvSpPr txBox="1"/>
          <p:nvPr/>
        </p:nvSpPr>
        <p:spPr>
          <a:xfrm>
            <a:off x="5311588" y="1809002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4A1DC65-D6EC-EDA2-EC03-A22CDA1446CB}"/>
              </a:ext>
            </a:extLst>
          </p:cNvPr>
          <p:cNvSpPr txBox="1"/>
          <p:nvPr/>
        </p:nvSpPr>
        <p:spPr>
          <a:xfrm>
            <a:off x="5594335" y="1809002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085DC4DE-3212-1123-CEFE-4235F106EA21}"/>
              </a:ext>
            </a:extLst>
          </p:cNvPr>
          <p:cNvSpPr txBox="1"/>
          <p:nvPr/>
        </p:nvSpPr>
        <p:spPr>
          <a:xfrm>
            <a:off x="6189797" y="1816366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F07F808-6D4A-C724-66D2-6C94B9C05752}"/>
              </a:ext>
            </a:extLst>
          </p:cNvPr>
          <p:cNvSpPr txBox="1"/>
          <p:nvPr/>
        </p:nvSpPr>
        <p:spPr>
          <a:xfrm rot="16200000">
            <a:off x="-148576" y="1069866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D02376D-3F53-D79D-1167-98FA461C989C}"/>
              </a:ext>
            </a:extLst>
          </p:cNvPr>
          <p:cNvSpPr txBox="1"/>
          <p:nvPr/>
        </p:nvSpPr>
        <p:spPr>
          <a:xfrm rot="16200000">
            <a:off x="2802900" y="993231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8D2EDF1-3B3F-FA6C-8528-799BAC852138}"/>
              </a:ext>
            </a:extLst>
          </p:cNvPr>
          <p:cNvSpPr txBox="1"/>
          <p:nvPr/>
        </p:nvSpPr>
        <p:spPr>
          <a:xfrm rot="16200000">
            <a:off x="4603773" y="1006822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16A8ED5-684A-6D85-016D-9D67C2E32874}"/>
              </a:ext>
            </a:extLst>
          </p:cNvPr>
          <p:cNvSpPr txBox="1"/>
          <p:nvPr/>
        </p:nvSpPr>
        <p:spPr>
          <a:xfrm>
            <a:off x="3385962" y="1460645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079BBFF-5B2F-5E77-5B4B-61ACD30C7E81}"/>
              </a:ext>
            </a:extLst>
          </p:cNvPr>
          <p:cNvSpPr txBox="1"/>
          <p:nvPr/>
        </p:nvSpPr>
        <p:spPr>
          <a:xfrm>
            <a:off x="5225720" y="147406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6067AC9-76D3-FDDC-7995-E455B764CE97}"/>
              </a:ext>
            </a:extLst>
          </p:cNvPr>
          <p:cNvSpPr txBox="1"/>
          <p:nvPr/>
        </p:nvSpPr>
        <p:spPr>
          <a:xfrm>
            <a:off x="908380" y="3536596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F6D2F8D-1F09-8F62-6027-A2F2ADCDF69D}"/>
              </a:ext>
            </a:extLst>
          </p:cNvPr>
          <p:cNvSpPr txBox="1"/>
          <p:nvPr/>
        </p:nvSpPr>
        <p:spPr>
          <a:xfrm rot="16200000">
            <a:off x="-141304" y="4343189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6421343-493A-AFB4-D4D2-98FD251BACF9}"/>
              </a:ext>
            </a:extLst>
          </p:cNvPr>
          <p:cNvSpPr txBox="1"/>
          <p:nvPr/>
        </p:nvSpPr>
        <p:spPr>
          <a:xfrm>
            <a:off x="3537412" y="349267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83A691D-B35E-9D80-923F-DE6159501B67}"/>
              </a:ext>
            </a:extLst>
          </p:cNvPr>
          <p:cNvSpPr txBox="1"/>
          <p:nvPr/>
        </p:nvSpPr>
        <p:spPr>
          <a:xfrm>
            <a:off x="3820159" y="3492673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F7351E2-EB67-2894-68D7-91F5CE36638E}"/>
              </a:ext>
            </a:extLst>
          </p:cNvPr>
          <p:cNvSpPr txBox="1"/>
          <p:nvPr/>
        </p:nvSpPr>
        <p:spPr>
          <a:xfrm>
            <a:off x="4415621" y="350003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71A05AB-A30D-2118-4026-6E69D866C0C4}"/>
              </a:ext>
            </a:extLst>
          </p:cNvPr>
          <p:cNvSpPr txBox="1"/>
          <p:nvPr/>
        </p:nvSpPr>
        <p:spPr>
          <a:xfrm>
            <a:off x="5331990" y="349267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3CAC33B-4801-46A3-7446-6EC8A2F7E71D}"/>
              </a:ext>
            </a:extLst>
          </p:cNvPr>
          <p:cNvSpPr txBox="1"/>
          <p:nvPr/>
        </p:nvSpPr>
        <p:spPr>
          <a:xfrm>
            <a:off x="5614737" y="3492673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8F2B429-07DE-B512-0C82-68A8474B27F6}"/>
              </a:ext>
            </a:extLst>
          </p:cNvPr>
          <p:cNvSpPr txBox="1"/>
          <p:nvPr/>
        </p:nvSpPr>
        <p:spPr>
          <a:xfrm>
            <a:off x="6210199" y="350003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842581F-AC3A-7258-F0E5-49827D7695A1}"/>
              </a:ext>
            </a:extLst>
          </p:cNvPr>
          <p:cNvSpPr txBox="1"/>
          <p:nvPr/>
        </p:nvSpPr>
        <p:spPr>
          <a:xfrm rot="16200000">
            <a:off x="4603773" y="2699466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AEAC0124-80EE-CE91-98E5-19D5E9D0760B}"/>
              </a:ext>
            </a:extLst>
          </p:cNvPr>
          <p:cNvSpPr txBox="1"/>
          <p:nvPr/>
        </p:nvSpPr>
        <p:spPr>
          <a:xfrm rot="16200000">
            <a:off x="2843097" y="2699466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F31B012-1F4E-C5ED-EC9D-E9DF1E254C92}"/>
              </a:ext>
            </a:extLst>
          </p:cNvPr>
          <p:cNvSpPr txBox="1"/>
          <p:nvPr/>
        </p:nvSpPr>
        <p:spPr>
          <a:xfrm>
            <a:off x="5394517" y="513451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53AA6AF-BC5B-944B-0AEE-910A19B6AFBC}"/>
              </a:ext>
            </a:extLst>
          </p:cNvPr>
          <p:cNvSpPr txBox="1"/>
          <p:nvPr/>
        </p:nvSpPr>
        <p:spPr>
          <a:xfrm>
            <a:off x="5677264" y="5134513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925C50B2-9A27-21F3-23E0-F463166B2D44}"/>
              </a:ext>
            </a:extLst>
          </p:cNvPr>
          <p:cNvSpPr txBox="1"/>
          <p:nvPr/>
        </p:nvSpPr>
        <p:spPr>
          <a:xfrm>
            <a:off x="6272726" y="514187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C4479CD-FD7A-62B0-2756-BAB355E8D097}"/>
              </a:ext>
            </a:extLst>
          </p:cNvPr>
          <p:cNvSpPr txBox="1"/>
          <p:nvPr/>
        </p:nvSpPr>
        <p:spPr>
          <a:xfrm rot="16200000">
            <a:off x="4595059" y="4383881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0B5D6CF-2B11-B64D-0D5B-324A4727D229}"/>
              </a:ext>
            </a:extLst>
          </p:cNvPr>
          <p:cNvSpPr txBox="1"/>
          <p:nvPr/>
        </p:nvSpPr>
        <p:spPr>
          <a:xfrm rot="16200000">
            <a:off x="2802900" y="435203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0BC1BBC2-19C8-6E2D-93FD-ECBEF895C02D}"/>
              </a:ext>
            </a:extLst>
          </p:cNvPr>
          <p:cNvSpPr txBox="1"/>
          <p:nvPr/>
        </p:nvSpPr>
        <p:spPr>
          <a:xfrm>
            <a:off x="3508362" y="5136761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1F9D1E0-3127-7290-706E-BE969011C942}"/>
              </a:ext>
            </a:extLst>
          </p:cNvPr>
          <p:cNvSpPr txBox="1"/>
          <p:nvPr/>
        </p:nvSpPr>
        <p:spPr>
          <a:xfrm>
            <a:off x="3791109" y="5136761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3714D21B-FDF2-CD6E-7B28-84542B23BC58}"/>
              </a:ext>
            </a:extLst>
          </p:cNvPr>
          <p:cNvSpPr txBox="1"/>
          <p:nvPr/>
        </p:nvSpPr>
        <p:spPr>
          <a:xfrm>
            <a:off x="4386571" y="5144125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56D918E-61C0-C8E7-E224-741EFED53B99}"/>
              </a:ext>
            </a:extLst>
          </p:cNvPr>
          <p:cNvSpPr txBox="1"/>
          <p:nvPr/>
        </p:nvSpPr>
        <p:spPr>
          <a:xfrm>
            <a:off x="903626" y="519361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8F68565F-E88B-EC4B-B3C1-309C277C4B67}"/>
              </a:ext>
            </a:extLst>
          </p:cNvPr>
          <p:cNvSpPr txBox="1"/>
          <p:nvPr/>
        </p:nvSpPr>
        <p:spPr>
          <a:xfrm rot="16200000">
            <a:off x="-112244" y="2760492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F9EFAAC2-81AF-7D06-0B87-B2210D3EE987}"/>
              </a:ext>
            </a:extLst>
          </p:cNvPr>
          <p:cNvSpPr txBox="1"/>
          <p:nvPr/>
        </p:nvSpPr>
        <p:spPr>
          <a:xfrm>
            <a:off x="541673" y="317887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D2FC57E6-2EA9-B67F-BD9C-7C4814C171BC}"/>
              </a:ext>
            </a:extLst>
          </p:cNvPr>
          <p:cNvSpPr txBox="1"/>
          <p:nvPr/>
        </p:nvSpPr>
        <p:spPr>
          <a:xfrm>
            <a:off x="3426145" y="3168392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6CB898A5-C6DC-A476-1165-1434AEAB5F25}"/>
              </a:ext>
            </a:extLst>
          </p:cNvPr>
          <p:cNvSpPr txBox="1"/>
          <p:nvPr/>
        </p:nvSpPr>
        <p:spPr>
          <a:xfrm>
            <a:off x="5255484" y="315867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7D9E243-B694-245E-AF69-5DF6FA6A5B7A}"/>
              </a:ext>
            </a:extLst>
          </p:cNvPr>
          <p:cNvSpPr txBox="1"/>
          <p:nvPr/>
        </p:nvSpPr>
        <p:spPr>
          <a:xfrm>
            <a:off x="517189" y="4834014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D7526DF-FC8B-0D4F-1CC1-52DF9395E594}"/>
              </a:ext>
            </a:extLst>
          </p:cNvPr>
          <p:cNvSpPr txBox="1"/>
          <p:nvPr/>
        </p:nvSpPr>
        <p:spPr>
          <a:xfrm>
            <a:off x="3400649" y="4837493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5737C58-A746-06C2-4426-8BA71286B397}"/>
              </a:ext>
            </a:extLst>
          </p:cNvPr>
          <p:cNvSpPr txBox="1"/>
          <p:nvPr/>
        </p:nvSpPr>
        <p:spPr>
          <a:xfrm>
            <a:off x="5250591" y="4837493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98E52AF4-DD79-CC65-D3C9-0EA9407AA3F1}"/>
              </a:ext>
            </a:extLst>
          </p:cNvPr>
          <p:cNvSpPr txBox="1"/>
          <p:nvPr/>
        </p:nvSpPr>
        <p:spPr>
          <a:xfrm>
            <a:off x="504764" y="647115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0C6B697-D8D5-7170-C6C0-7354CEE9E1E7}"/>
              </a:ext>
            </a:extLst>
          </p:cNvPr>
          <p:cNvSpPr txBox="1"/>
          <p:nvPr/>
        </p:nvSpPr>
        <p:spPr>
          <a:xfrm>
            <a:off x="3374461" y="6519145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BF0F30CF-99B4-1D6C-A621-2ED534B6DC8A}"/>
              </a:ext>
            </a:extLst>
          </p:cNvPr>
          <p:cNvSpPr txBox="1"/>
          <p:nvPr/>
        </p:nvSpPr>
        <p:spPr>
          <a:xfrm>
            <a:off x="5224202" y="648983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C404C97-8ED3-97FD-FD03-8358BCD845D1}"/>
              </a:ext>
            </a:extLst>
          </p:cNvPr>
          <p:cNvSpPr txBox="1"/>
          <p:nvPr/>
        </p:nvSpPr>
        <p:spPr>
          <a:xfrm>
            <a:off x="903626" y="6858556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0C7FBF68-A9BF-5F49-BCAF-3C19AD359FD1}"/>
              </a:ext>
            </a:extLst>
          </p:cNvPr>
          <p:cNvSpPr txBox="1"/>
          <p:nvPr/>
        </p:nvSpPr>
        <p:spPr>
          <a:xfrm rot="16200000">
            <a:off x="-164931" y="5979096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B91687ED-9E60-2C9D-AC9E-6684E4A6B1B9}"/>
              </a:ext>
            </a:extLst>
          </p:cNvPr>
          <p:cNvSpPr txBox="1"/>
          <p:nvPr/>
        </p:nvSpPr>
        <p:spPr>
          <a:xfrm rot="16200000">
            <a:off x="2820995" y="599856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FD2F9A04-21AF-01B1-FD34-1203E7CB1330}"/>
              </a:ext>
            </a:extLst>
          </p:cNvPr>
          <p:cNvSpPr txBox="1"/>
          <p:nvPr/>
        </p:nvSpPr>
        <p:spPr>
          <a:xfrm rot="16200000">
            <a:off x="4603773" y="5987377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DF42DF61-8875-8AB9-F067-5FF59219E637}"/>
              </a:ext>
            </a:extLst>
          </p:cNvPr>
          <p:cNvSpPr txBox="1"/>
          <p:nvPr/>
        </p:nvSpPr>
        <p:spPr>
          <a:xfrm>
            <a:off x="3513792" y="680159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0E6E0A88-E160-737C-4072-F6CB9517E930}"/>
              </a:ext>
            </a:extLst>
          </p:cNvPr>
          <p:cNvSpPr txBox="1"/>
          <p:nvPr/>
        </p:nvSpPr>
        <p:spPr>
          <a:xfrm>
            <a:off x="3796539" y="6801598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9218A7F9-1FD2-26EB-142F-180144DA7E45}"/>
              </a:ext>
            </a:extLst>
          </p:cNvPr>
          <p:cNvSpPr txBox="1"/>
          <p:nvPr/>
        </p:nvSpPr>
        <p:spPr>
          <a:xfrm>
            <a:off x="4392001" y="680896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FB77CDA7-24E5-6560-D53A-8F94E85246F7}"/>
              </a:ext>
            </a:extLst>
          </p:cNvPr>
          <p:cNvSpPr txBox="1"/>
          <p:nvPr/>
        </p:nvSpPr>
        <p:spPr>
          <a:xfrm>
            <a:off x="5394517" y="6803666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DD3930F-9D18-9782-29B0-03E4A0E6B118}"/>
              </a:ext>
            </a:extLst>
          </p:cNvPr>
          <p:cNvSpPr txBox="1"/>
          <p:nvPr/>
        </p:nvSpPr>
        <p:spPr>
          <a:xfrm>
            <a:off x="5677264" y="6803666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312AE685-D32C-65A4-5A80-F63CDEE2B0F1}"/>
              </a:ext>
            </a:extLst>
          </p:cNvPr>
          <p:cNvSpPr txBox="1"/>
          <p:nvPr/>
        </p:nvSpPr>
        <p:spPr>
          <a:xfrm>
            <a:off x="6272726" y="6811030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62716D3C-3660-0FED-6BB2-2779CC5A6839}"/>
              </a:ext>
            </a:extLst>
          </p:cNvPr>
          <p:cNvSpPr txBox="1"/>
          <p:nvPr/>
        </p:nvSpPr>
        <p:spPr>
          <a:xfrm>
            <a:off x="874654" y="8506017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926EE030-B478-2841-678D-00D1B23069C5}"/>
              </a:ext>
            </a:extLst>
          </p:cNvPr>
          <p:cNvSpPr txBox="1"/>
          <p:nvPr/>
        </p:nvSpPr>
        <p:spPr>
          <a:xfrm rot="16200000">
            <a:off x="-161078" y="7616756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65E735D-343D-4015-346B-F3AD9059BC71}"/>
              </a:ext>
            </a:extLst>
          </p:cNvPr>
          <p:cNvSpPr txBox="1"/>
          <p:nvPr/>
        </p:nvSpPr>
        <p:spPr>
          <a:xfrm>
            <a:off x="3521757" y="844958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B972A81C-8A7A-77D7-085A-D2031E18C1AA}"/>
              </a:ext>
            </a:extLst>
          </p:cNvPr>
          <p:cNvSpPr txBox="1"/>
          <p:nvPr/>
        </p:nvSpPr>
        <p:spPr>
          <a:xfrm>
            <a:off x="3804504" y="8449589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0A5103B6-11A9-ADBB-8676-EC1554E0C324}"/>
              </a:ext>
            </a:extLst>
          </p:cNvPr>
          <p:cNvSpPr txBox="1"/>
          <p:nvPr/>
        </p:nvSpPr>
        <p:spPr>
          <a:xfrm>
            <a:off x="4399966" y="8456953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546831F-13A5-E10E-B389-CC5D4961707F}"/>
              </a:ext>
            </a:extLst>
          </p:cNvPr>
          <p:cNvSpPr txBox="1"/>
          <p:nvPr/>
        </p:nvSpPr>
        <p:spPr>
          <a:xfrm>
            <a:off x="5362537" y="845695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16E7E739-E789-2D88-188B-135E0CFF5C64}"/>
              </a:ext>
            </a:extLst>
          </p:cNvPr>
          <p:cNvSpPr txBox="1"/>
          <p:nvPr/>
        </p:nvSpPr>
        <p:spPr>
          <a:xfrm>
            <a:off x="5645284" y="8456953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76FFBD59-ED6B-83D9-786E-C02514965A5D}"/>
              </a:ext>
            </a:extLst>
          </p:cNvPr>
          <p:cNvSpPr txBox="1"/>
          <p:nvPr/>
        </p:nvSpPr>
        <p:spPr>
          <a:xfrm>
            <a:off x="6240746" y="846431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865DB9EE-5EF5-894C-63E7-EF05BBD28BDD}"/>
              </a:ext>
            </a:extLst>
          </p:cNvPr>
          <p:cNvSpPr txBox="1"/>
          <p:nvPr/>
        </p:nvSpPr>
        <p:spPr>
          <a:xfrm rot="16200000">
            <a:off x="2816294" y="7679240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3D6E0AAC-1575-CBCA-ABF9-FF1B1616EBF6}"/>
              </a:ext>
            </a:extLst>
          </p:cNvPr>
          <p:cNvSpPr txBox="1"/>
          <p:nvPr/>
        </p:nvSpPr>
        <p:spPr>
          <a:xfrm rot="16200000">
            <a:off x="4595058" y="7679239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47AF5AC-A82E-75C3-5E15-8243ABCAD5ED}"/>
              </a:ext>
            </a:extLst>
          </p:cNvPr>
          <p:cNvSpPr txBox="1"/>
          <p:nvPr/>
        </p:nvSpPr>
        <p:spPr>
          <a:xfrm>
            <a:off x="517189" y="8143985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AEDCF652-2473-E60E-5FD4-CA5F92A18A16}"/>
              </a:ext>
            </a:extLst>
          </p:cNvPr>
          <p:cNvSpPr txBox="1"/>
          <p:nvPr/>
        </p:nvSpPr>
        <p:spPr>
          <a:xfrm>
            <a:off x="3416051" y="8226125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1B231E7F-6C19-0A0C-CF7A-47304A3514A3}"/>
              </a:ext>
            </a:extLst>
          </p:cNvPr>
          <p:cNvSpPr txBox="1"/>
          <p:nvPr/>
        </p:nvSpPr>
        <p:spPr>
          <a:xfrm>
            <a:off x="5267853" y="8144855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3210CEA9-EECB-4DF0-64BF-9535B106CF0E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025794" y="500370"/>
            <a:ext cx="951059" cy="676715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2375D1C7-9FC5-424D-3DE7-9F48336DA55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025793" y="2206887"/>
            <a:ext cx="951059" cy="676715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C4CBA5B7-5225-6F4F-5B27-F29CAFEAFF1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86360" y="3877458"/>
            <a:ext cx="951059" cy="676715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48167086-7698-0363-41BA-FD1337173E4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71378" y="5553876"/>
            <a:ext cx="951059" cy="676715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A3257A6D-C2D3-AF5E-01D3-054C35E962C9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025792" y="7213838"/>
            <a:ext cx="951059" cy="6767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3036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45</Words>
  <Application>Microsoft Office PowerPoint</Application>
  <PresentationFormat>画面に合わせる (4:3)</PresentationFormat>
  <Paragraphs>6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博之</dc:creator>
  <cp:lastModifiedBy>山本 博之</cp:lastModifiedBy>
  <cp:revision>2</cp:revision>
  <dcterms:created xsi:type="dcterms:W3CDTF">2022-06-01T23:49:07Z</dcterms:created>
  <dcterms:modified xsi:type="dcterms:W3CDTF">2022-08-23T08:50:18Z</dcterms:modified>
</cp:coreProperties>
</file>